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C815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000" autoAdjust="0"/>
  </p:normalViewPr>
  <p:slideViewPr>
    <p:cSldViewPr snapToGrid="0" snapToObjects="1">
      <p:cViewPr>
        <p:scale>
          <a:sx n="99" d="100"/>
          <a:sy n="99" d="100"/>
        </p:scale>
        <p:origin x="-456" y="-8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Mihir:POWDERY_MILDEW_DRAFT_PAPER:Powdery%20mildew%20paper%20figures%2001%2018%2019:PMS%208%20DPI%20UP%20with%20PMS%20down%20comparison%20050520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Mihir:POWDERY_MILDEW_DRAFT_PAPER:Powdery%20mildew%20paper%20figures%2001%2018%2019:PMS%208%20DPI%20UP%20with%20PMS%20down%20comparison%20050520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Mihir:POWDERY_MILDEW_DRAFT_PAPER:Powdery%20mildew%20paper%20figures%2001%2018%2019:New%20PMS%208DPI%20up%20and%20down%20all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%20OSX:Users:bidishachanda:Mihir:POWDERY_MILDEW_DRAFT_PAPER:Powdery%20mildew%20paper%20figures%2001%2018%2019:New%20PMS%208DPI%20up%20and%20down%20al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40"/>
    </mc:Choice>
    <mc:Fallback>
      <c:style val="40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917815833547961"/>
          <c:y val="0.0425531914893617"/>
          <c:w val="0.83815685127547"/>
          <c:h val="0.32572238617472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combined bp comparison'!$M$113</c:f>
              <c:strCache>
                <c:ptCount val="1"/>
                <c:pt idx="0">
                  <c:v>PMS_8DPI_UP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combined bp comparison'!$L$114:$L$160</c:f>
              <c:strCache>
                <c:ptCount val="47"/>
                <c:pt idx="0">
                  <c:v>cellular process</c:v>
                </c:pt>
                <c:pt idx="1">
                  <c:v>single-organism process</c:v>
                </c:pt>
                <c:pt idx="2">
                  <c:v>response to stimulus</c:v>
                </c:pt>
                <c:pt idx="3">
                  <c:v>metabolic process</c:v>
                </c:pt>
                <c:pt idx="4">
                  <c:v>response to stress</c:v>
                </c:pt>
                <c:pt idx="5">
                  <c:v>primary metabolic process</c:v>
                </c:pt>
                <c:pt idx="6">
                  <c:v>organic substance metabolic process</c:v>
                </c:pt>
                <c:pt idx="7">
                  <c:v>response to abiotic stimulus</c:v>
                </c:pt>
                <c:pt idx="8">
                  <c:v>developmental process</c:v>
                </c:pt>
                <c:pt idx="9">
                  <c:v>anatomical structure development</c:v>
                </c:pt>
                <c:pt idx="10">
                  <c:v>single-organism developmental process</c:v>
                </c:pt>
                <c:pt idx="11">
                  <c:v>multicellular organismal process</c:v>
                </c:pt>
                <c:pt idx="12">
                  <c:v>biosynthetic process</c:v>
                </c:pt>
                <c:pt idx="13">
                  <c:v>response to endogenous stimulus</c:v>
                </c:pt>
                <c:pt idx="14">
                  <c:v>cellular metabolic process</c:v>
                </c:pt>
                <c:pt idx="15">
                  <c:v>response to external stimulus</c:v>
                </c:pt>
                <c:pt idx="16">
                  <c:v>single-organism metabolic process</c:v>
                </c:pt>
                <c:pt idx="17">
                  <c:v>response to biotic stimulus</c:v>
                </c:pt>
                <c:pt idx="18">
                  <c:v>reproduction</c:v>
                </c:pt>
                <c:pt idx="19">
                  <c:v>nitrogen compound metabolic process</c:v>
                </c:pt>
                <c:pt idx="20">
                  <c:v>cellular component organization or biogenesis</c:v>
                </c:pt>
                <c:pt idx="21">
                  <c:v>nucleobase-containing compound metabolic process</c:v>
                </c:pt>
                <c:pt idx="22">
                  <c:v>macromolecule metabolic process</c:v>
                </c:pt>
                <c:pt idx="23">
                  <c:v>cell communication</c:v>
                </c:pt>
                <c:pt idx="24">
                  <c:v>protein metabolic process</c:v>
                </c:pt>
                <c:pt idx="25">
                  <c:v>cellular macromolecule metabolic process</c:v>
                </c:pt>
                <c:pt idx="26">
                  <c:v>regulation of biological process</c:v>
                </c:pt>
                <c:pt idx="27">
                  <c:v>transport</c:v>
                </c:pt>
                <c:pt idx="28">
                  <c:v>signaling</c:v>
                </c:pt>
                <c:pt idx="29">
                  <c:v>localization</c:v>
                </c:pt>
                <c:pt idx="30">
                  <c:v>signal transduction</c:v>
                </c:pt>
                <c:pt idx="31">
                  <c:v>cellular response to stimulus</c:v>
                </c:pt>
                <c:pt idx="32">
                  <c:v>cellular protein metabolic process</c:v>
                </c:pt>
                <c:pt idx="33">
                  <c:v>reproductive process</c:v>
                </c:pt>
                <c:pt idx="34">
                  <c:v>secondary metabolic process</c:v>
                </c:pt>
                <c:pt idx="35">
                  <c:v>growth</c:v>
                </c:pt>
                <c:pt idx="36">
                  <c:v>catabolic process</c:v>
                </c:pt>
                <c:pt idx="37">
                  <c:v>protein modification process</c:v>
                </c:pt>
                <c:pt idx="38">
                  <c:v>cell differentiation</c:v>
                </c:pt>
                <c:pt idx="39">
                  <c:v>developmental process involved in reproduction</c:v>
                </c:pt>
                <c:pt idx="40">
                  <c:v>single organism reproductive process</c:v>
                </c:pt>
                <c:pt idx="41">
                  <c:v>reproductive structure development</c:v>
                </c:pt>
                <c:pt idx="42">
                  <c:v>cell growth</c:v>
                </c:pt>
                <c:pt idx="43">
                  <c:v>flower development</c:v>
                </c:pt>
                <c:pt idx="44">
                  <c:v>shoot system development</c:v>
                </c:pt>
                <c:pt idx="45">
                  <c:v>single-organism transport</c:v>
                </c:pt>
                <c:pt idx="46">
                  <c:v>carbohydrate metabolic process</c:v>
                </c:pt>
              </c:strCache>
            </c:strRef>
          </c:cat>
          <c:val>
            <c:numRef>
              <c:f>'combined bp comparison'!$M$114:$M$160</c:f>
              <c:numCache>
                <c:formatCode>General</c:formatCode>
                <c:ptCount val="47"/>
                <c:pt idx="0">
                  <c:v>602.0</c:v>
                </c:pt>
                <c:pt idx="1">
                  <c:v>543.0</c:v>
                </c:pt>
                <c:pt idx="2">
                  <c:v>541.0</c:v>
                </c:pt>
                <c:pt idx="3">
                  <c:v>515.0</c:v>
                </c:pt>
                <c:pt idx="4">
                  <c:v>414.0</c:v>
                </c:pt>
                <c:pt idx="5">
                  <c:v>373.0</c:v>
                </c:pt>
                <c:pt idx="6">
                  <c:v>373.0</c:v>
                </c:pt>
                <c:pt idx="7">
                  <c:v>342.0</c:v>
                </c:pt>
                <c:pt idx="8">
                  <c:v>340.0</c:v>
                </c:pt>
                <c:pt idx="9">
                  <c:v>337.0</c:v>
                </c:pt>
                <c:pt idx="10">
                  <c:v>332.0</c:v>
                </c:pt>
                <c:pt idx="11">
                  <c:v>329.0</c:v>
                </c:pt>
                <c:pt idx="12">
                  <c:v>295.0</c:v>
                </c:pt>
                <c:pt idx="13">
                  <c:v>289.0</c:v>
                </c:pt>
                <c:pt idx="14">
                  <c:v>279.0</c:v>
                </c:pt>
                <c:pt idx="15">
                  <c:v>278.0</c:v>
                </c:pt>
                <c:pt idx="16">
                  <c:v>250.0</c:v>
                </c:pt>
                <c:pt idx="17">
                  <c:v>226.0</c:v>
                </c:pt>
                <c:pt idx="18">
                  <c:v>205.0</c:v>
                </c:pt>
                <c:pt idx="19">
                  <c:v>189.0</c:v>
                </c:pt>
                <c:pt idx="20">
                  <c:v>184.0</c:v>
                </c:pt>
                <c:pt idx="21">
                  <c:v>171.0</c:v>
                </c:pt>
                <c:pt idx="22">
                  <c:v>162.0</c:v>
                </c:pt>
                <c:pt idx="23">
                  <c:v>160.0</c:v>
                </c:pt>
                <c:pt idx="24">
                  <c:v>149.0</c:v>
                </c:pt>
                <c:pt idx="25">
                  <c:v>137.0</c:v>
                </c:pt>
                <c:pt idx="26">
                  <c:v>133.0</c:v>
                </c:pt>
                <c:pt idx="27">
                  <c:v>126.0</c:v>
                </c:pt>
                <c:pt idx="28">
                  <c:v>126.0</c:v>
                </c:pt>
                <c:pt idx="29">
                  <c:v>126.0</c:v>
                </c:pt>
                <c:pt idx="30">
                  <c:v>125.0</c:v>
                </c:pt>
                <c:pt idx="31">
                  <c:v>125.0</c:v>
                </c:pt>
                <c:pt idx="32">
                  <c:v>123.0</c:v>
                </c:pt>
                <c:pt idx="33">
                  <c:v>115.0</c:v>
                </c:pt>
                <c:pt idx="34">
                  <c:v>100.0</c:v>
                </c:pt>
                <c:pt idx="35">
                  <c:v>100.0</c:v>
                </c:pt>
                <c:pt idx="36">
                  <c:v>97.0</c:v>
                </c:pt>
                <c:pt idx="37">
                  <c:v>94.0</c:v>
                </c:pt>
                <c:pt idx="38">
                  <c:v>88.0</c:v>
                </c:pt>
                <c:pt idx="39">
                  <c:v>78.0</c:v>
                </c:pt>
                <c:pt idx="40">
                  <c:v>78.0</c:v>
                </c:pt>
                <c:pt idx="41">
                  <c:v>78.0</c:v>
                </c:pt>
                <c:pt idx="42">
                  <c:v>77.0</c:v>
                </c:pt>
                <c:pt idx="43">
                  <c:v>76.0</c:v>
                </c:pt>
                <c:pt idx="44">
                  <c:v>76.0</c:v>
                </c:pt>
                <c:pt idx="45">
                  <c:v>67.0</c:v>
                </c:pt>
                <c:pt idx="46">
                  <c:v>65.0</c:v>
                </c:pt>
              </c:numCache>
            </c:numRef>
          </c:val>
        </c:ser>
        <c:ser>
          <c:idx val="1"/>
          <c:order val="1"/>
          <c:tx>
            <c:strRef>
              <c:f>'combined bp comparison'!$N$113</c:f>
              <c:strCache>
                <c:ptCount val="1"/>
                <c:pt idx="0">
                  <c:v>PMS_8DPI_DN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</c:spPr>
          <c:invertIfNegative val="0"/>
          <c:cat>
            <c:strRef>
              <c:f>'combined bp comparison'!$L$114:$L$160</c:f>
              <c:strCache>
                <c:ptCount val="47"/>
                <c:pt idx="0">
                  <c:v>cellular process</c:v>
                </c:pt>
                <c:pt idx="1">
                  <c:v>single-organism process</c:v>
                </c:pt>
                <c:pt idx="2">
                  <c:v>response to stimulus</c:v>
                </c:pt>
                <c:pt idx="3">
                  <c:v>metabolic process</c:v>
                </c:pt>
                <c:pt idx="4">
                  <c:v>response to stress</c:v>
                </c:pt>
                <c:pt idx="5">
                  <c:v>primary metabolic process</c:v>
                </c:pt>
                <c:pt idx="6">
                  <c:v>organic substance metabolic process</c:v>
                </c:pt>
                <c:pt idx="7">
                  <c:v>response to abiotic stimulus</c:v>
                </c:pt>
                <c:pt idx="8">
                  <c:v>developmental process</c:v>
                </c:pt>
                <c:pt idx="9">
                  <c:v>anatomical structure development</c:v>
                </c:pt>
                <c:pt idx="10">
                  <c:v>single-organism developmental process</c:v>
                </c:pt>
                <c:pt idx="11">
                  <c:v>multicellular organismal process</c:v>
                </c:pt>
                <c:pt idx="12">
                  <c:v>biosynthetic process</c:v>
                </c:pt>
                <c:pt idx="13">
                  <c:v>response to endogenous stimulus</c:v>
                </c:pt>
                <c:pt idx="14">
                  <c:v>cellular metabolic process</c:v>
                </c:pt>
                <c:pt idx="15">
                  <c:v>response to external stimulus</c:v>
                </c:pt>
                <c:pt idx="16">
                  <c:v>single-organism metabolic process</c:v>
                </c:pt>
                <c:pt idx="17">
                  <c:v>response to biotic stimulus</c:v>
                </c:pt>
                <c:pt idx="18">
                  <c:v>reproduction</c:v>
                </c:pt>
                <c:pt idx="19">
                  <c:v>nitrogen compound metabolic process</c:v>
                </c:pt>
                <c:pt idx="20">
                  <c:v>cellular component organization or biogenesis</c:v>
                </c:pt>
                <c:pt idx="21">
                  <c:v>nucleobase-containing compound metabolic process</c:v>
                </c:pt>
                <c:pt idx="22">
                  <c:v>macromolecule metabolic process</c:v>
                </c:pt>
                <c:pt idx="23">
                  <c:v>cell communication</c:v>
                </c:pt>
                <c:pt idx="24">
                  <c:v>protein metabolic process</c:v>
                </c:pt>
                <c:pt idx="25">
                  <c:v>cellular macromolecule metabolic process</c:v>
                </c:pt>
                <c:pt idx="26">
                  <c:v>regulation of biological process</c:v>
                </c:pt>
                <c:pt idx="27">
                  <c:v>transport</c:v>
                </c:pt>
                <c:pt idx="28">
                  <c:v>signaling</c:v>
                </c:pt>
                <c:pt idx="29">
                  <c:v>localization</c:v>
                </c:pt>
                <c:pt idx="30">
                  <c:v>signal transduction</c:v>
                </c:pt>
                <c:pt idx="31">
                  <c:v>cellular response to stimulus</c:v>
                </c:pt>
                <c:pt idx="32">
                  <c:v>cellular protein metabolic process</c:v>
                </c:pt>
                <c:pt idx="33">
                  <c:v>reproductive process</c:v>
                </c:pt>
                <c:pt idx="34">
                  <c:v>secondary metabolic process</c:v>
                </c:pt>
                <c:pt idx="35">
                  <c:v>growth</c:v>
                </c:pt>
                <c:pt idx="36">
                  <c:v>catabolic process</c:v>
                </c:pt>
                <c:pt idx="37">
                  <c:v>protein modification process</c:v>
                </c:pt>
                <c:pt idx="38">
                  <c:v>cell differentiation</c:v>
                </c:pt>
                <c:pt idx="39">
                  <c:v>developmental process involved in reproduction</c:v>
                </c:pt>
                <c:pt idx="40">
                  <c:v>single organism reproductive process</c:v>
                </c:pt>
                <c:pt idx="41">
                  <c:v>reproductive structure development</c:v>
                </c:pt>
                <c:pt idx="42">
                  <c:v>cell growth</c:v>
                </c:pt>
                <c:pt idx="43">
                  <c:v>flower development</c:v>
                </c:pt>
                <c:pt idx="44">
                  <c:v>shoot system development</c:v>
                </c:pt>
                <c:pt idx="45">
                  <c:v>single-organism transport</c:v>
                </c:pt>
                <c:pt idx="46">
                  <c:v>carbohydrate metabolic process</c:v>
                </c:pt>
              </c:strCache>
            </c:strRef>
          </c:cat>
          <c:val>
            <c:numRef>
              <c:f>'combined bp comparison'!$N$114:$N$160</c:f>
              <c:numCache>
                <c:formatCode>General</c:formatCode>
                <c:ptCount val="47"/>
                <c:pt idx="0">
                  <c:v>550.0</c:v>
                </c:pt>
                <c:pt idx="1">
                  <c:v>460.0</c:v>
                </c:pt>
                <c:pt idx="2">
                  <c:v>420.0</c:v>
                </c:pt>
                <c:pt idx="3">
                  <c:v>504.0</c:v>
                </c:pt>
                <c:pt idx="4">
                  <c:v>300.0</c:v>
                </c:pt>
                <c:pt idx="5">
                  <c:v>352.0</c:v>
                </c:pt>
                <c:pt idx="6">
                  <c:v>353.0</c:v>
                </c:pt>
                <c:pt idx="7">
                  <c:v>283.0</c:v>
                </c:pt>
                <c:pt idx="8">
                  <c:v>243.0</c:v>
                </c:pt>
                <c:pt idx="9">
                  <c:v>242.0</c:v>
                </c:pt>
                <c:pt idx="10">
                  <c:v>235.0</c:v>
                </c:pt>
                <c:pt idx="11">
                  <c:v>232.0</c:v>
                </c:pt>
                <c:pt idx="12">
                  <c:v>281.0</c:v>
                </c:pt>
                <c:pt idx="13">
                  <c:v>212.0</c:v>
                </c:pt>
                <c:pt idx="14">
                  <c:v>282.0</c:v>
                </c:pt>
                <c:pt idx="15">
                  <c:v>163.0</c:v>
                </c:pt>
                <c:pt idx="16">
                  <c:v>254.0</c:v>
                </c:pt>
                <c:pt idx="17">
                  <c:v>112.0</c:v>
                </c:pt>
                <c:pt idx="18">
                  <c:v>146.0</c:v>
                </c:pt>
                <c:pt idx="19">
                  <c:v>155.0</c:v>
                </c:pt>
                <c:pt idx="20">
                  <c:v>191.0</c:v>
                </c:pt>
                <c:pt idx="21">
                  <c:v>138.0</c:v>
                </c:pt>
                <c:pt idx="22">
                  <c:v>154.0</c:v>
                </c:pt>
                <c:pt idx="23">
                  <c:v>113.0</c:v>
                </c:pt>
                <c:pt idx="24">
                  <c:v>141.0</c:v>
                </c:pt>
                <c:pt idx="25">
                  <c:v>125.0</c:v>
                </c:pt>
                <c:pt idx="26">
                  <c:v>90.0</c:v>
                </c:pt>
                <c:pt idx="27">
                  <c:v>137.0</c:v>
                </c:pt>
                <c:pt idx="28">
                  <c:v>87.0</c:v>
                </c:pt>
                <c:pt idx="29">
                  <c:v>137.0</c:v>
                </c:pt>
                <c:pt idx="30">
                  <c:v>86.0</c:v>
                </c:pt>
                <c:pt idx="31">
                  <c:v>86.0</c:v>
                </c:pt>
                <c:pt idx="32">
                  <c:v>115.0</c:v>
                </c:pt>
                <c:pt idx="33">
                  <c:v>68.0</c:v>
                </c:pt>
                <c:pt idx="34">
                  <c:v>40.0</c:v>
                </c:pt>
                <c:pt idx="35">
                  <c:v>63.0</c:v>
                </c:pt>
                <c:pt idx="36">
                  <c:v>74.0</c:v>
                </c:pt>
                <c:pt idx="37">
                  <c:v>87.0</c:v>
                </c:pt>
                <c:pt idx="38">
                  <c:v>44.0</c:v>
                </c:pt>
                <c:pt idx="39">
                  <c:v>43.0</c:v>
                </c:pt>
                <c:pt idx="40">
                  <c:v>43.0</c:v>
                </c:pt>
                <c:pt idx="41">
                  <c:v>43.0</c:v>
                </c:pt>
                <c:pt idx="42">
                  <c:v>49.0</c:v>
                </c:pt>
                <c:pt idx="43">
                  <c:v>42.0</c:v>
                </c:pt>
                <c:pt idx="44">
                  <c:v>42.0</c:v>
                </c:pt>
                <c:pt idx="45">
                  <c:v>84.0</c:v>
                </c:pt>
                <c:pt idx="46">
                  <c:v>86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35460280"/>
        <c:axId val="-2140723304"/>
      </c:barChart>
      <c:catAx>
        <c:axId val="-21354602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 b="1"/>
            </a:pPr>
            <a:endParaRPr lang="en-US"/>
          </a:p>
        </c:txPr>
        <c:crossAx val="-2140723304"/>
        <c:crosses val="autoZero"/>
        <c:auto val="1"/>
        <c:lblAlgn val="ctr"/>
        <c:lblOffset val="100"/>
        <c:noMultiLvlLbl val="0"/>
      </c:catAx>
      <c:valAx>
        <c:axId val="-2140723304"/>
        <c:scaling>
          <c:orientation val="minMax"/>
        </c:scaling>
        <c:delete val="0"/>
        <c:axPos val="l"/>
        <c:majorGridlines>
          <c:spPr>
            <a:ln w="3175" cmpd="sng">
              <a:solidFill>
                <a:schemeClr val="dk1">
                  <a:tint val="75000"/>
                  <a:shade val="95000"/>
                  <a:satMod val="105000"/>
                </a:schemeClr>
              </a:solidFill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NO. of</a:t>
                </a:r>
                <a:r>
                  <a:rPr lang="en-US" sz="1100" baseline="0"/>
                  <a:t> DEGs</a:t>
                </a:r>
                <a:endParaRPr lang="en-US" sz="11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135460280"/>
        <c:crosses val="autoZero"/>
        <c:crossBetween val="between"/>
      </c:valAx>
      <c:spPr>
        <a:noFill/>
      </c:spPr>
    </c:plotArea>
    <c:legend>
      <c:legendPos val="r"/>
      <c:layout>
        <c:manualLayout>
          <c:xMode val="edge"/>
          <c:yMode val="edge"/>
          <c:x val="0.439342031933671"/>
          <c:y val="0.0578300707501579"/>
          <c:w val="0.147811453690648"/>
          <c:h val="0.131475701380208"/>
        </c:manualLayout>
      </c:layout>
      <c:overlay val="0"/>
      <c:spPr>
        <a:solidFill>
          <a:schemeClr val="bg1"/>
        </a:solidFill>
      </c:spPr>
      <c:txPr>
        <a:bodyPr/>
        <a:lstStyle/>
        <a:p>
          <a:pPr>
            <a:defRPr sz="1000" b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2375748196922"/>
          <c:y val="0.0601851851851852"/>
          <c:w val="0.771545658595991"/>
          <c:h val="0.44538969087197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COMBINED MF'!$C$38</c:f>
              <c:strCache>
                <c:ptCount val="1"/>
                <c:pt idx="0">
                  <c:v>PMS_8DPI_UP</c:v>
                </c:pt>
              </c:strCache>
            </c:strRef>
          </c:tx>
          <c:spPr>
            <a:solidFill>
              <a:schemeClr val="accent2"/>
            </a:solidFill>
            <a:effectLst/>
          </c:spPr>
          <c:invertIfNegative val="0"/>
          <c:cat>
            <c:strRef>
              <c:f>'COMBINED MF'!$B$39:$B$71</c:f>
              <c:strCache>
                <c:ptCount val="33"/>
                <c:pt idx="0">
                  <c:v>nucleotide binding</c:v>
                </c:pt>
                <c:pt idx="1">
                  <c:v>nucleic acid binding transcription factor activity</c:v>
                </c:pt>
                <c:pt idx="2">
                  <c:v>nucleic acid binding</c:v>
                </c:pt>
                <c:pt idx="3">
                  <c:v>DNA binding</c:v>
                </c:pt>
                <c:pt idx="4">
                  <c:v>chromatin binding</c:v>
                </c:pt>
                <c:pt idx="5">
                  <c:v>transcription factor activity, sequence-specific DNA binding</c:v>
                </c:pt>
                <c:pt idx="6">
                  <c:v>RNA binding</c:v>
                </c:pt>
                <c:pt idx="7">
                  <c:v>catalytic activity</c:v>
                </c:pt>
                <c:pt idx="8">
                  <c:v>nuclease activity</c:v>
                </c:pt>
                <c:pt idx="9">
                  <c:v>signal transducer activity</c:v>
                </c:pt>
                <c:pt idx="10">
                  <c:v>receptor activity</c:v>
                </c:pt>
                <c:pt idx="11">
                  <c:v>receptor binding</c:v>
                </c:pt>
                <c:pt idx="12">
                  <c:v>structural molecule activity</c:v>
                </c:pt>
                <c:pt idx="13">
                  <c:v>transporter activity</c:v>
                </c:pt>
                <c:pt idx="14">
                  <c:v>binding</c:v>
                </c:pt>
                <c:pt idx="15">
                  <c:v>protein binding</c:v>
                </c:pt>
                <c:pt idx="16">
                  <c:v>translation factor activity, RNA binding</c:v>
                </c:pt>
                <c:pt idx="17">
                  <c:v>lipid binding</c:v>
                </c:pt>
                <c:pt idx="18">
                  <c:v>kinase activity</c:v>
                </c:pt>
                <c:pt idx="19">
                  <c:v>transferase activity</c:v>
                </c:pt>
                <c:pt idx="20">
                  <c:v>transferase activity, transferring phosphorus-containing groups</c:v>
                </c:pt>
                <c:pt idx="21">
                  <c:v>hydrolase activity</c:v>
                </c:pt>
                <c:pt idx="22">
                  <c:v>hydrolase activity, acting on ester bonds</c:v>
                </c:pt>
                <c:pt idx="23">
                  <c:v>oxygen binding</c:v>
                </c:pt>
                <c:pt idx="24">
                  <c:v>enzyme regulator activity</c:v>
                </c:pt>
                <c:pt idx="25">
                  <c:v>carbohydrate binding</c:v>
                </c:pt>
                <c:pt idx="26">
                  <c:v>small molecule binding</c:v>
                </c:pt>
                <c:pt idx="27">
                  <c:v>molecular transducer activity</c:v>
                </c:pt>
                <c:pt idx="28">
                  <c:v>organic cyclic compound binding</c:v>
                </c:pt>
                <c:pt idx="29">
                  <c:v>molecular function regulator</c:v>
                </c:pt>
                <c:pt idx="30">
                  <c:v>nucleoside phosphate binding</c:v>
                </c:pt>
                <c:pt idx="31">
                  <c:v>heterocyclic compound binding</c:v>
                </c:pt>
                <c:pt idx="32">
                  <c:v>pyrophosphatase activity</c:v>
                </c:pt>
              </c:strCache>
            </c:strRef>
          </c:cat>
          <c:val>
            <c:numRef>
              <c:f>'COMBINED MF'!$C$39:$C$71</c:f>
              <c:numCache>
                <c:formatCode>General</c:formatCode>
                <c:ptCount val="33"/>
                <c:pt idx="0">
                  <c:v>139.0</c:v>
                </c:pt>
                <c:pt idx="1">
                  <c:v>79.0</c:v>
                </c:pt>
                <c:pt idx="2">
                  <c:v>168.0</c:v>
                </c:pt>
                <c:pt idx="3">
                  <c:v>103.0</c:v>
                </c:pt>
                <c:pt idx="4">
                  <c:v>7.0</c:v>
                </c:pt>
                <c:pt idx="5">
                  <c:v>77.0</c:v>
                </c:pt>
                <c:pt idx="6">
                  <c:v>71.0</c:v>
                </c:pt>
                <c:pt idx="7">
                  <c:v>441.0</c:v>
                </c:pt>
                <c:pt idx="8">
                  <c:v>9.0</c:v>
                </c:pt>
                <c:pt idx="9">
                  <c:v>37.0</c:v>
                </c:pt>
                <c:pt idx="10">
                  <c:v>30.0</c:v>
                </c:pt>
                <c:pt idx="11">
                  <c:v>3.0</c:v>
                </c:pt>
                <c:pt idx="12">
                  <c:v>28.0</c:v>
                </c:pt>
                <c:pt idx="13">
                  <c:v>65.0</c:v>
                </c:pt>
                <c:pt idx="14">
                  <c:v>557.0</c:v>
                </c:pt>
                <c:pt idx="15">
                  <c:v>328.0</c:v>
                </c:pt>
                <c:pt idx="16">
                  <c:v>7.0</c:v>
                </c:pt>
                <c:pt idx="17">
                  <c:v>13.0</c:v>
                </c:pt>
                <c:pt idx="18">
                  <c:v>77.0</c:v>
                </c:pt>
                <c:pt idx="19">
                  <c:v>184.0</c:v>
                </c:pt>
                <c:pt idx="20">
                  <c:v>77.0</c:v>
                </c:pt>
                <c:pt idx="21">
                  <c:v>135.0</c:v>
                </c:pt>
                <c:pt idx="22">
                  <c:v>9.0</c:v>
                </c:pt>
                <c:pt idx="23">
                  <c:v>11.0</c:v>
                </c:pt>
                <c:pt idx="24">
                  <c:v>11.0</c:v>
                </c:pt>
                <c:pt idx="25">
                  <c:v>16.0</c:v>
                </c:pt>
                <c:pt idx="26">
                  <c:v>139.0</c:v>
                </c:pt>
                <c:pt idx="27">
                  <c:v>30.0</c:v>
                </c:pt>
                <c:pt idx="28">
                  <c:v>277.0</c:v>
                </c:pt>
                <c:pt idx="29">
                  <c:v>11.0</c:v>
                </c:pt>
                <c:pt idx="30">
                  <c:v>139.0</c:v>
                </c:pt>
                <c:pt idx="31">
                  <c:v>277.0</c:v>
                </c:pt>
                <c:pt idx="32">
                  <c:v>0.0</c:v>
                </c:pt>
              </c:numCache>
            </c:numRef>
          </c:val>
        </c:ser>
        <c:ser>
          <c:idx val="1"/>
          <c:order val="1"/>
          <c:tx>
            <c:strRef>
              <c:f>'COMBINED MF'!$D$38</c:f>
              <c:strCache>
                <c:ptCount val="1"/>
                <c:pt idx="0">
                  <c:v>PMS_8DPI_DN</c:v>
                </c:pt>
              </c:strCache>
            </c:strRef>
          </c:tx>
          <c:spPr>
            <a:solidFill>
              <a:srgbClr val="0000FF"/>
            </a:solidFill>
            <a:effectLst/>
          </c:spPr>
          <c:invertIfNegative val="0"/>
          <c:cat>
            <c:strRef>
              <c:f>'COMBINED MF'!$B$39:$B$71</c:f>
              <c:strCache>
                <c:ptCount val="33"/>
                <c:pt idx="0">
                  <c:v>nucleotide binding</c:v>
                </c:pt>
                <c:pt idx="1">
                  <c:v>nucleic acid binding transcription factor activity</c:v>
                </c:pt>
                <c:pt idx="2">
                  <c:v>nucleic acid binding</c:v>
                </c:pt>
                <c:pt idx="3">
                  <c:v>DNA binding</c:v>
                </c:pt>
                <c:pt idx="4">
                  <c:v>chromatin binding</c:v>
                </c:pt>
                <c:pt idx="5">
                  <c:v>transcription factor activity, sequence-specific DNA binding</c:v>
                </c:pt>
                <c:pt idx="6">
                  <c:v>RNA binding</c:v>
                </c:pt>
                <c:pt idx="7">
                  <c:v>catalytic activity</c:v>
                </c:pt>
                <c:pt idx="8">
                  <c:v>nuclease activity</c:v>
                </c:pt>
                <c:pt idx="9">
                  <c:v>signal transducer activity</c:v>
                </c:pt>
                <c:pt idx="10">
                  <c:v>receptor activity</c:v>
                </c:pt>
                <c:pt idx="11">
                  <c:v>receptor binding</c:v>
                </c:pt>
                <c:pt idx="12">
                  <c:v>structural molecule activity</c:v>
                </c:pt>
                <c:pt idx="13">
                  <c:v>transporter activity</c:v>
                </c:pt>
                <c:pt idx="14">
                  <c:v>binding</c:v>
                </c:pt>
                <c:pt idx="15">
                  <c:v>protein binding</c:v>
                </c:pt>
                <c:pt idx="16">
                  <c:v>translation factor activity, RNA binding</c:v>
                </c:pt>
                <c:pt idx="17">
                  <c:v>lipid binding</c:v>
                </c:pt>
                <c:pt idx="18">
                  <c:v>kinase activity</c:v>
                </c:pt>
                <c:pt idx="19">
                  <c:v>transferase activity</c:v>
                </c:pt>
                <c:pt idx="20">
                  <c:v>transferase activity, transferring phosphorus-containing groups</c:v>
                </c:pt>
                <c:pt idx="21">
                  <c:v>hydrolase activity</c:v>
                </c:pt>
                <c:pt idx="22">
                  <c:v>hydrolase activity, acting on ester bonds</c:v>
                </c:pt>
                <c:pt idx="23">
                  <c:v>oxygen binding</c:v>
                </c:pt>
                <c:pt idx="24">
                  <c:v>enzyme regulator activity</c:v>
                </c:pt>
                <c:pt idx="25">
                  <c:v>carbohydrate binding</c:v>
                </c:pt>
                <c:pt idx="26">
                  <c:v>small molecule binding</c:v>
                </c:pt>
                <c:pt idx="27">
                  <c:v>molecular transducer activity</c:v>
                </c:pt>
                <c:pt idx="28">
                  <c:v>organic cyclic compound binding</c:v>
                </c:pt>
                <c:pt idx="29">
                  <c:v>molecular function regulator</c:v>
                </c:pt>
                <c:pt idx="30">
                  <c:v>nucleoside phosphate binding</c:v>
                </c:pt>
                <c:pt idx="31">
                  <c:v>heterocyclic compound binding</c:v>
                </c:pt>
                <c:pt idx="32">
                  <c:v>pyrophosphatase activity</c:v>
                </c:pt>
              </c:strCache>
            </c:strRef>
          </c:cat>
          <c:val>
            <c:numRef>
              <c:f>'COMBINED MF'!$D$39:$D$71</c:f>
              <c:numCache>
                <c:formatCode>General</c:formatCode>
                <c:ptCount val="33"/>
                <c:pt idx="0">
                  <c:v>133.0</c:v>
                </c:pt>
                <c:pt idx="1">
                  <c:v>43.0</c:v>
                </c:pt>
                <c:pt idx="2">
                  <c:v>115.0</c:v>
                </c:pt>
                <c:pt idx="3">
                  <c:v>58.0</c:v>
                </c:pt>
                <c:pt idx="4">
                  <c:v>3.0</c:v>
                </c:pt>
                <c:pt idx="5">
                  <c:v>42.0</c:v>
                </c:pt>
                <c:pt idx="6">
                  <c:v>58.0</c:v>
                </c:pt>
                <c:pt idx="7">
                  <c:v>412.0</c:v>
                </c:pt>
                <c:pt idx="8">
                  <c:v>8.0</c:v>
                </c:pt>
                <c:pt idx="9">
                  <c:v>25.0</c:v>
                </c:pt>
                <c:pt idx="10">
                  <c:v>20.0</c:v>
                </c:pt>
                <c:pt idx="11">
                  <c:v>5.0</c:v>
                </c:pt>
                <c:pt idx="12">
                  <c:v>18.0</c:v>
                </c:pt>
                <c:pt idx="13">
                  <c:v>99.0</c:v>
                </c:pt>
                <c:pt idx="14">
                  <c:v>453.0</c:v>
                </c:pt>
                <c:pt idx="15">
                  <c:v>250.0</c:v>
                </c:pt>
                <c:pt idx="16">
                  <c:v>5.0</c:v>
                </c:pt>
                <c:pt idx="17">
                  <c:v>7.0</c:v>
                </c:pt>
                <c:pt idx="18">
                  <c:v>64.0</c:v>
                </c:pt>
                <c:pt idx="19">
                  <c:v>164.0</c:v>
                </c:pt>
                <c:pt idx="20">
                  <c:v>64.0</c:v>
                </c:pt>
                <c:pt idx="21">
                  <c:v>156.0</c:v>
                </c:pt>
                <c:pt idx="22">
                  <c:v>8.0</c:v>
                </c:pt>
                <c:pt idx="23">
                  <c:v>11.0</c:v>
                </c:pt>
                <c:pt idx="24">
                  <c:v>17.0</c:v>
                </c:pt>
                <c:pt idx="25">
                  <c:v>4.0</c:v>
                </c:pt>
                <c:pt idx="26">
                  <c:v>133.0</c:v>
                </c:pt>
                <c:pt idx="27">
                  <c:v>20.0</c:v>
                </c:pt>
                <c:pt idx="28">
                  <c:v>218.0</c:v>
                </c:pt>
                <c:pt idx="29">
                  <c:v>17.0</c:v>
                </c:pt>
                <c:pt idx="30">
                  <c:v>133.0</c:v>
                </c:pt>
                <c:pt idx="31">
                  <c:v>218.0</c:v>
                </c:pt>
                <c:pt idx="32">
                  <c:v>6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30427960"/>
        <c:axId val="2130159256"/>
      </c:barChart>
      <c:catAx>
        <c:axId val="213042796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500" b="1"/>
            </a:pPr>
            <a:endParaRPr lang="en-US"/>
          </a:p>
        </c:txPr>
        <c:crossAx val="2130159256"/>
        <c:crosses val="autoZero"/>
        <c:auto val="1"/>
        <c:lblAlgn val="ctr"/>
        <c:lblOffset val="100"/>
        <c:noMultiLvlLbl val="0"/>
      </c:catAx>
      <c:valAx>
        <c:axId val="2130159256"/>
        <c:scaling>
          <c:orientation val="minMax"/>
        </c:scaling>
        <c:delete val="0"/>
        <c:axPos val="l"/>
        <c:majorGridlines>
          <c:spPr>
            <a:ln w="3175" cmpd="sng"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o. of DEG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130427960"/>
        <c:crosses val="autoZero"/>
        <c:crossBetween val="between"/>
      </c:valAx>
      <c:spPr>
        <a:ln w="3175" cmpd="sng">
          <a:prstDash val="dashDot"/>
        </a:ln>
      </c:spPr>
    </c:plotArea>
    <c:legend>
      <c:legendPos val="r"/>
      <c:layout>
        <c:manualLayout>
          <c:xMode val="edge"/>
          <c:yMode val="edge"/>
          <c:x val="0.270822105570137"/>
          <c:y val="0.0690605861767279"/>
          <c:w val="0.301859436186079"/>
          <c:h val="0.185952901720618"/>
        </c:manualLayout>
      </c:layout>
      <c:overlay val="0"/>
      <c:spPr>
        <a:solidFill>
          <a:schemeClr val="bg1"/>
        </a:solidFill>
      </c:spPr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3771622664814"/>
          <c:y val="0.0620525059665871"/>
          <c:w val="0.375136637332098"/>
          <c:h val="0.809037641177908"/>
        </c:manualLayout>
      </c:layout>
      <c:barChart>
        <c:barDir val="bar"/>
        <c:grouping val="clustered"/>
        <c:varyColors val="0"/>
        <c:ser>
          <c:idx val="0"/>
          <c:order val="0"/>
          <c:spPr>
            <a:pattFill prst="pct80">
              <a:fgClr>
                <a:srgbClr val="008000"/>
              </a:fgClr>
              <a:bgClr>
                <a:prstClr val="white"/>
              </a:bgClr>
            </a:pattFill>
          </c:spPr>
          <c:invertIfNegative val="0"/>
          <c:cat>
            <c:strRef>
              <c:f>mf!$C$2:$C$28</c:f>
              <c:strCache>
                <c:ptCount val="27"/>
                <c:pt idx="0">
                  <c:v>pyrophosphatase activity</c:v>
                </c:pt>
                <c:pt idx="1">
                  <c:v>receptor binding</c:v>
                </c:pt>
                <c:pt idx="2">
                  <c:v>chromatin binding</c:v>
                </c:pt>
                <c:pt idx="3">
                  <c:v>translation factor activity, RNA binding</c:v>
                </c:pt>
                <c:pt idx="4">
                  <c:v>nuclease activity</c:v>
                </c:pt>
                <c:pt idx="5">
                  <c:v>lipid binding</c:v>
                </c:pt>
                <c:pt idx="6">
                  <c:v>carbohydrate binding</c:v>
                </c:pt>
                <c:pt idx="7">
                  <c:v>enzyme regulator activity</c:v>
                </c:pt>
                <c:pt idx="8">
                  <c:v>molecular function regulator</c:v>
                </c:pt>
                <c:pt idx="9">
                  <c:v>structural molecule activity</c:v>
                </c:pt>
                <c:pt idx="10">
                  <c:v>molecular transducer activity</c:v>
                </c:pt>
                <c:pt idx="11">
                  <c:v>receptor activity</c:v>
                </c:pt>
                <c:pt idx="12">
                  <c:v>signal transducer activity</c:v>
                </c:pt>
                <c:pt idx="13">
                  <c:v>transcription factor activity</c:v>
                </c:pt>
                <c:pt idx="14">
                  <c:v>nucleic acid binding transcription factor activity</c:v>
                </c:pt>
                <c:pt idx="15">
                  <c:v>RNA binding</c:v>
                </c:pt>
                <c:pt idx="16">
                  <c:v>transferase activity</c:v>
                </c:pt>
                <c:pt idx="17">
                  <c:v>kinase activity</c:v>
                </c:pt>
                <c:pt idx="18">
                  <c:v>DNA binding</c:v>
                </c:pt>
                <c:pt idx="19">
                  <c:v>transporter activity</c:v>
                </c:pt>
                <c:pt idx="20">
                  <c:v>small molecule binding</c:v>
                </c:pt>
                <c:pt idx="21">
                  <c:v>nucleic acid binding</c:v>
                </c:pt>
                <c:pt idx="22">
                  <c:v>hydrolase activity</c:v>
                </c:pt>
                <c:pt idx="23">
                  <c:v>transferase activity</c:v>
                </c:pt>
                <c:pt idx="24">
                  <c:v>protein binding</c:v>
                </c:pt>
                <c:pt idx="25">
                  <c:v>catalytic activity</c:v>
                </c:pt>
                <c:pt idx="26">
                  <c:v>binding</c:v>
                </c:pt>
              </c:strCache>
            </c:strRef>
          </c:cat>
          <c:val>
            <c:numRef>
              <c:f>mf!$D$2:$D$28</c:f>
              <c:numCache>
                <c:formatCode>General</c:formatCode>
                <c:ptCount val="27"/>
                <c:pt idx="0">
                  <c:v>7.0</c:v>
                </c:pt>
                <c:pt idx="1">
                  <c:v>8.0</c:v>
                </c:pt>
                <c:pt idx="2">
                  <c:v>10.0</c:v>
                </c:pt>
                <c:pt idx="3">
                  <c:v>12.0</c:v>
                </c:pt>
                <c:pt idx="4">
                  <c:v>17.0</c:v>
                </c:pt>
                <c:pt idx="5">
                  <c:v>20.0</c:v>
                </c:pt>
                <c:pt idx="6">
                  <c:v>20.0</c:v>
                </c:pt>
                <c:pt idx="7">
                  <c:v>28.0</c:v>
                </c:pt>
                <c:pt idx="8">
                  <c:v>28.0</c:v>
                </c:pt>
                <c:pt idx="9">
                  <c:v>46.0</c:v>
                </c:pt>
                <c:pt idx="10">
                  <c:v>50.0</c:v>
                </c:pt>
                <c:pt idx="11">
                  <c:v>50.0</c:v>
                </c:pt>
                <c:pt idx="12">
                  <c:v>62.0</c:v>
                </c:pt>
                <c:pt idx="13">
                  <c:v>119.0</c:v>
                </c:pt>
                <c:pt idx="14">
                  <c:v>122.0</c:v>
                </c:pt>
                <c:pt idx="15">
                  <c:v>129.0</c:v>
                </c:pt>
                <c:pt idx="16">
                  <c:v>141.0</c:v>
                </c:pt>
                <c:pt idx="17">
                  <c:v>141.0</c:v>
                </c:pt>
                <c:pt idx="18">
                  <c:v>161.0</c:v>
                </c:pt>
                <c:pt idx="19">
                  <c:v>164.0</c:v>
                </c:pt>
                <c:pt idx="20">
                  <c:v>272.0</c:v>
                </c:pt>
                <c:pt idx="21">
                  <c:v>283.0</c:v>
                </c:pt>
                <c:pt idx="22">
                  <c:v>291.0</c:v>
                </c:pt>
                <c:pt idx="23">
                  <c:v>348.0</c:v>
                </c:pt>
                <c:pt idx="24">
                  <c:v>578.0</c:v>
                </c:pt>
                <c:pt idx="25">
                  <c:v>853.0</c:v>
                </c:pt>
                <c:pt idx="26">
                  <c:v>1010.0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2095426168"/>
        <c:axId val="-2146802168"/>
      </c:barChart>
      <c:catAx>
        <c:axId val="2095426168"/>
        <c:scaling>
          <c:orientation val="minMax"/>
        </c:scaling>
        <c:delete val="0"/>
        <c:axPos val="l"/>
        <c:majorTickMark val="none"/>
        <c:minorTickMark val="none"/>
        <c:tickLblPos val="nextTo"/>
        <c:txPr>
          <a:bodyPr/>
          <a:lstStyle/>
          <a:p>
            <a:pPr>
              <a:defRPr sz="500" b="1"/>
            </a:pPr>
            <a:endParaRPr lang="en-US"/>
          </a:p>
        </c:txPr>
        <c:crossAx val="-2146802168"/>
        <c:crosses val="autoZero"/>
        <c:auto val="1"/>
        <c:lblAlgn val="ctr"/>
        <c:lblOffset val="100"/>
        <c:noMultiLvlLbl val="0"/>
      </c:catAx>
      <c:valAx>
        <c:axId val="-2146802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20954261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07590433042748"/>
          <c:y val="0.0246950254107474"/>
          <c:w val="0.414734378229374"/>
          <c:h val="0.938830168372711"/>
        </c:manualLayout>
      </c:layout>
      <c:barChart>
        <c:barDir val="bar"/>
        <c:grouping val="clustered"/>
        <c:varyColors val="0"/>
        <c:ser>
          <c:idx val="0"/>
          <c:order val="0"/>
          <c:spPr>
            <a:pattFill prst="pct80">
              <a:fgClr>
                <a:srgbClr val="660066"/>
              </a:fgClr>
              <a:bgClr>
                <a:prstClr val="white"/>
              </a:bgClr>
            </a:pattFill>
          </c:spPr>
          <c:invertIfNegative val="0"/>
          <c:dLbls>
            <c:txPr>
              <a:bodyPr/>
              <a:lstStyle/>
              <a:p>
                <a:pPr>
                  <a:defRPr sz="50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cc!$C$2:$C$52</c:f>
              <c:strCache>
                <c:ptCount val="51"/>
                <c:pt idx="0">
                  <c:v>lytic vacuole</c:v>
                </c:pt>
                <c:pt idx="1">
                  <c:v>lysosome</c:v>
                </c:pt>
                <c:pt idx="2">
                  <c:v>proteinaceous extracellular matrix</c:v>
                </c:pt>
                <c:pt idx="3">
                  <c:v>extracellular matrix</c:v>
                </c:pt>
                <c:pt idx="4">
                  <c:v>organelle envelope</c:v>
                </c:pt>
                <c:pt idx="5">
                  <c:v>extracellular space</c:v>
                </c:pt>
                <c:pt idx="6">
                  <c:v>nuclear envelope</c:v>
                </c:pt>
                <c:pt idx="7">
                  <c:v>envelope</c:v>
                </c:pt>
                <c:pt idx="8">
                  <c:v>extracellular region part</c:v>
                </c:pt>
                <c:pt idx="9">
                  <c:v>cytoskeleton</c:v>
                </c:pt>
                <c:pt idx="10">
                  <c:v>nucleoplasm</c:v>
                </c:pt>
                <c:pt idx="11">
                  <c:v>vesicle</c:v>
                </c:pt>
                <c:pt idx="12">
                  <c:v>endosome</c:v>
                </c:pt>
                <c:pt idx="13">
                  <c:v>intracellular vesicle</c:v>
                </c:pt>
                <c:pt idx="14">
                  <c:v>cytoplasmic vesicle</c:v>
                </c:pt>
                <c:pt idx="15">
                  <c:v>peroxisome</c:v>
                </c:pt>
                <c:pt idx="16">
                  <c:v>microbody</c:v>
                </c:pt>
                <c:pt idx="17">
                  <c:v>macromolecular complex</c:v>
                </c:pt>
                <c:pt idx="18">
                  <c:v>ribonucleoprotein complex</c:v>
                </c:pt>
                <c:pt idx="19">
                  <c:v>intracellular ribonucleoprotein complex</c:v>
                </c:pt>
                <c:pt idx="20">
                  <c:v>ribosome</c:v>
                </c:pt>
                <c:pt idx="21">
                  <c:v>nucleolus</c:v>
                </c:pt>
                <c:pt idx="22">
                  <c:v>membrane-enclosed lumen</c:v>
                </c:pt>
                <c:pt idx="23">
                  <c:v>organelle lumen</c:v>
                </c:pt>
                <c:pt idx="24">
                  <c:v>intracellular organelle lumen</c:v>
                </c:pt>
                <c:pt idx="25">
                  <c:v>nuclear lumen</c:v>
                </c:pt>
                <c:pt idx="26">
                  <c:v>intracellular organelle part</c:v>
                </c:pt>
                <c:pt idx="27">
                  <c:v>nuclear part</c:v>
                </c:pt>
                <c:pt idx="28">
                  <c:v>organelle part</c:v>
                </c:pt>
                <c:pt idx="29">
                  <c:v>endoplasmic reticulum</c:v>
                </c:pt>
                <c:pt idx="30">
                  <c:v>non-membrane-bounded organelle</c:v>
                </c:pt>
                <c:pt idx="31">
                  <c:v>intracellular non-membrane-bounded organelle</c:v>
                </c:pt>
                <c:pt idx="32">
                  <c:v>external encapsulating structure</c:v>
                </c:pt>
                <c:pt idx="33">
                  <c:v>cell wall</c:v>
                </c:pt>
                <c:pt idx="34">
                  <c:v>thylakoid</c:v>
                </c:pt>
                <c:pt idx="35">
                  <c:v>Golgi apparatus</c:v>
                </c:pt>
                <c:pt idx="36">
                  <c:v>extracellular region</c:v>
                </c:pt>
                <c:pt idx="37">
                  <c:v>vacuole</c:v>
                </c:pt>
                <c:pt idx="38">
                  <c:v>mitochondrion</c:v>
                </c:pt>
                <c:pt idx="39">
                  <c:v>endomembrane system</c:v>
                </c:pt>
                <c:pt idx="40">
                  <c:v>cytosol</c:v>
                </c:pt>
                <c:pt idx="41">
                  <c:v>plasma membrane</c:v>
                </c:pt>
                <c:pt idx="42">
                  <c:v>nucleus</c:v>
                </c:pt>
                <c:pt idx="43">
                  <c:v>cell periphery</c:v>
                </c:pt>
                <c:pt idx="44">
                  <c:v>plastid</c:v>
                </c:pt>
                <c:pt idx="45">
                  <c:v>membrane</c:v>
                </c:pt>
                <c:pt idx="46">
                  <c:v>cytoplasm</c:v>
                </c:pt>
                <c:pt idx="47">
                  <c:v>intracellular organelle</c:v>
                </c:pt>
                <c:pt idx="48">
                  <c:v>intracellular</c:v>
                </c:pt>
                <c:pt idx="49">
                  <c:v>cell part</c:v>
                </c:pt>
                <c:pt idx="50">
                  <c:v>cell</c:v>
                </c:pt>
              </c:strCache>
            </c:strRef>
          </c:cat>
          <c:val>
            <c:numRef>
              <c:f>cc!$D$2:$D$52</c:f>
              <c:numCache>
                <c:formatCode>General</c:formatCode>
                <c:ptCount val="51"/>
                <c:pt idx="0">
                  <c:v>3.0</c:v>
                </c:pt>
                <c:pt idx="1">
                  <c:v>3.0</c:v>
                </c:pt>
                <c:pt idx="2">
                  <c:v>4.0</c:v>
                </c:pt>
                <c:pt idx="3">
                  <c:v>4.0</c:v>
                </c:pt>
                <c:pt idx="4">
                  <c:v>12.0</c:v>
                </c:pt>
                <c:pt idx="5">
                  <c:v>12.0</c:v>
                </c:pt>
                <c:pt idx="6">
                  <c:v>12.0</c:v>
                </c:pt>
                <c:pt idx="7">
                  <c:v>12.0</c:v>
                </c:pt>
                <c:pt idx="8">
                  <c:v>15.0</c:v>
                </c:pt>
                <c:pt idx="9">
                  <c:v>31.0</c:v>
                </c:pt>
                <c:pt idx="10">
                  <c:v>32.0</c:v>
                </c:pt>
                <c:pt idx="11">
                  <c:v>53.0</c:v>
                </c:pt>
                <c:pt idx="12">
                  <c:v>53.0</c:v>
                </c:pt>
                <c:pt idx="13">
                  <c:v>53.0</c:v>
                </c:pt>
                <c:pt idx="14">
                  <c:v>53.0</c:v>
                </c:pt>
                <c:pt idx="15">
                  <c:v>57.0</c:v>
                </c:pt>
                <c:pt idx="16">
                  <c:v>57.0</c:v>
                </c:pt>
                <c:pt idx="17">
                  <c:v>63.0</c:v>
                </c:pt>
                <c:pt idx="18">
                  <c:v>63.0</c:v>
                </c:pt>
                <c:pt idx="19">
                  <c:v>63.0</c:v>
                </c:pt>
                <c:pt idx="20">
                  <c:v>63.0</c:v>
                </c:pt>
                <c:pt idx="21">
                  <c:v>82.0</c:v>
                </c:pt>
                <c:pt idx="22">
                  <c:v>103.0</c:v>
                </c:pt>
                <c:pt idx="23">
                  <c:v>103.0</c:v>
                </c:pt>
                <c:pt idx="24">
                  <c:v>103.0</c:v>
                </c:pt>
                <c:pt idx="25">
                  <c:v>103.0</c:v>
                </c:pt>
                <c:pt idx="26">
                  <c:v>115.0</c:v>
                </c:pt>
                <c:pt idx="27">
                  <c:v>115.0</c:v>
                </c:pt>
                <c:pt idx="28">
                  <c:v>115.0</c:v>
                </c:pt>
                <c:pt idx="29">
                  <c:v>140.0</c:v>
                </c:pt>
                <c:pt idx="30">
                  <c:v>149.0</c:v>
                </c:pt>
                <c:pt idx="31">
                  <c:v>149.0</c:v>
                </c:pt>
                <c:pt idx="32">
                  <c:v>183.0</c:v>
                </c:pt>
                <c:pt idx="33">
                  <c:v>183.0</c:v>
                </c:pt>
                <c:pt idx="34">
                  <c:v>205.0</c:v>
                </c:pt>
                <c:pt idx="35">
                  <c:v>212.0</c:v>
                </c:pt>
                <c:pt idx="36">
                  <c:v>261.0</c:v>
                </c:pt>
                <c:pt idx="37">
                  <c:v>277.0</c:v>
                </c:pt>
                <c:pt idx="38">
                  <c:v>315.0</c:v>
                </c:pt>
                <c:pt idx="39">
                  <c:v>317.0</c:v>
                </c:pt>
                <c:pt idx="40">
                  <c:v>438.0</c:v>
                </c:pt>
                <c:pt idx="41">
                  <c:v>551.0</c:v>
                </c:pt>
                <c:pt idx="42">
                  <c:v>611.0</c:v>
                </c:pt>
                <c:pt idx="43">
                  <c:v>636.0</c:v>
                </c:pt>
                <c:pt idx="44">
                  <c:v>739.0</c:v>
                </c:pt>
                <c:pt idx="45">
                  <c:v>911.0</c:v>
                </c:pt>
                <c:pt idx="46">
                  <c:v>1299.0</c:v>
                </c:pt>
                <c:pt idx="47">
                  <c:v>1368.0</c:v>
                </c:pt>
                <c:pt idx="48">
                  <c:v>1501.0</c:v>
                </c:pt>
                <c:pt idx="49">
                  <c:v>1563.0</c:v>
                </c:pt>
                <c:pt idx="50">
                  <c:v>1573.0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-2140725832"/>
        <c:axId val="-2135475960"/>
      </c:barChart>
      <c:catAx>
        <c:axId val="-2140725832"/>
        <c:scaling>
          <c:orientation val="minMax"/>
        </c:scaling>
        <c:delete val="0"/>
        <c:axPos val="l"/>
        <c:majorTickMark val="none"/>
        <c:minorTickMark val="none"/>
        <c:tickLblPos val="nextTo"/>
        <c:txPr>
          <a:bodyPr/>
          <a:lstStyle/>
          <a:p>
            <a:pPr>
              <a:defRPr sz="500" b="1"/>
            </a:pPr>
            <a:endParaRPr lang="en-US"/>
          </a:p>
        </c:txPr>
        <c:crossAx val="-2135475960"/>
        <c:crosses val="autoZero"/>
        <c:auto val="1"/>
        <c:lblAlgn val="ctr"/>
        <c:lblOffset val="100"/>
        <c:noMultiLvlLbl val="0"/>
      </c:catAx>
      <c:valAx>
        <c:axId val="-2135475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-21407258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6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13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939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245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435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702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164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339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012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182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189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80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52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image" Target="../media/image2.emf"/><Relationship Id="rId8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-73250" y="343190"/>
            <a:ext cx="7251815" cy="8796330"/>
            <a:chOff x="-85950" y="546390"/>
            <a:chExt cx="7251815" cy="8796330"/>
          </a:xfrm>
        </p:grpSpPr>
        <p:sp>
          <p:nvSpPr>
            <p:cNvPr id="12" name="TextBox 11"/>
            <p:cNvSpPr txBox="1"/>
            <p:nvPr/>
          </p:nvSpPr>
          <p:spPr>
            <a:xfrm>
              <a:off x="18921" y="546390"/>
              <a:ext cx="6347711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Figure_S1. </a:t>
              </a:r>
              <a:r>
                <a:rPr lang="en-US" sz="1000" dirty="0">
                  <a:latin typeface="Arial"/>
                  <a:cs typeface="Arial"/>
                </a:rPr>
                <a:t>Distribution of differentially expressed transcripts/genes (DEGs) involved in biological processes, </a:t>
              </a:r>
              <a:endParaRPr lang="en-US" sz="1000" dirty="0" smtClean="0">
                <a:latin typeface="Arial"/>
                <a:cs typeface="Arial"/>
              </a:endParaRPr>
            </a:p>
            <a:p>
              <a:r>
                <a:rPr lang="en-US" sz="1000" dirty="0" smtClean="0">
                  <a:latin typeface="Arial"/>
                  <a:cs typeface="Arial"/>
                </a:rPr>
                <a:t>molecular </a:t>
              </a:r>
              <a:r>
                <a:rPr lang="en-US" sz="1000" dirty="0">
                  <a:latin typeface="Arial"/>
                  <a:cs typeface="Arial"/>
                </a:rPr>
                <a:t>functions and cellular components in USVL677-PMS at 8 dpi. </a:t>
              </a:r>
            </a:p>
            <a:p>
              <a:r>
                <a:rPr lang="en-US" sz="1000" b="1" dirty="0" smtClean="0">
                  <a:latin typeface="Arial"/>
                  <a:cs typeface="Arial"/>
                </a:rPr>
                <a:t> 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3" name="Rectangle 292"/>
            <p:cNvSpPr>
              <a:spLocks noChangeArrowheads="1"/>
            </p:cNvSpPr>
            <p:nvPr/>
          </p:nvSpPr>
          <p:spPr bwMode="auto">
            <a:xfrm>
              <a:off x="-13007" y="841397"/>
              <a:ext cx="405317" cy="30777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/>
            <a:p>
              <a:pPr algn="ctr" fontAlgn="b">
                <a:defRPr/>
              </a:pPr>
              <a:r>
                <a:rPr lang="en-US" sz="1400" b="1" dirty="0">
                  <a:latin typeface="+mj-lt"/>
                  <a:ea typeface="ＭＳ Ｐゴシック" charset="0"/>
                </a:rPr>
                <a:t>(A)</a:t>
              </a:r>
            </a:p>
          </p:txBody>
        </p:sp>
        <p:sp>
          <p:nvSpPr>
            <p:cNvPr id="306" name="TextBox 305"/>
            <p:cNvSpPr txBox="1"/>
            <p:nvPr/>
          </p:nvSpPr>
          <p:spPr>
            <a:xfrm>
              <a:off x="5968106" y="5151295"/>
              <a:ext cx="43274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/>
                  <a:cs typeface="Arial"/>
                </a:rPr>
                <a:t># </a:t>
              </a:r>
              <a:r>
                <a:rPr lang="en-US" sz="600" b="1" dirty="0" err="1" smtClean="0">
                  <a:latin typeface="Arial"/>
                  <a:cs typeface="Arial"/>
                </a:rPr>
                <a:t>Seqs</a:t>
              </a:r>
              <a:endParaRPr lang="en-US" sz="600" b="1" dirty="0" smtClean="0">
                <a:latin typeface="Arial"/>
                <a:cs typeface="Arial"/>
              </a:endParaRPr>
            </a:p>
          </p:txBody>
        </p:sp>
        <p:sp>
          <p:nvSpPr>
            <p:cNvPr id="308" name="TextBox 307"/>
            <p:cNvSpPr txBox="1"/>
            <p:nvPr/>
          </p:nvSpPr>
          <p:spPr>
            <a:xfrm>
              <a:off x="4227710" y="5151907"/>
              <a:ext cx="43274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/>
                  <a:cs typeface="Arial"/>
                </a:rPr>
                <a:t># </a:t>
              </a:r>
              <a:r>
                <a:rPr lang="en-US" sz="600" b="1" dirty="0" err="1" smtClean="0">
                  <a:latin typeface="Arial"/>
                  <a:cs typeface="Arial"/>
                </a:rPr>
                <a:t>Seqs</a:t>
              </a:r>
              <a:endParaRPr lang="en-US" sz="600" b="1" dirty="0" smtClean="0">
                <a:latin typeface="Arial"/>
                <a:cs typeface="Arial"/>
              </a:endParaRPr>
            </a:p>
          </p:txBody>
        </p:sp>
        <p:sp>
          <p:nvSpPr>
            <p:cNvPr id="25" name="Rectangle 292"/>
            <p:cNvSpPr>
              <a:spLocks noChangeArrowheads="1"/>
            </p:cNvSpPr>
            <p:nvPr/>
          </p:nvSpPr>
          <p:spPr bwMode="auto">
            <a:xfrm>
              <a:off x="-57136" y="6542806"/>
              <a:ext cx="391554" cy="30777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/>
            <a:p>
              <a:pPr algn="ctr" fontAlgn="b">
                <a:defRPr/>
              </a:pPr>
              <a:r>
                <a:rPr lang="en-US" sz="1400" b="1" dirty="0" smtClean="0">
                  <a:latin typeface="+mj-lt"/>
                  <a:ea typeface="ＭＳ Ｐゴシック" charset="0"/>
                </a:rPr>
                <a:t>(C)</a:t>
              </a:r>
              <a:endParaRPr lang="en-US" sz="1400" b="1" dirty="0">
                <a:latin typeface="+mj-lt"/>
                <a:ea typeface="ＭＳ Ｐゴシック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555299" y="938074"/>
              <a:ext cx="6255948" cy="260334"/>
              <a:chOff x="555299" y="715486"/>
              <a:chExt cx="6255948" cy="260334"/>
            </a:xfrm>
          </p:grpSpPr>
          <p:sp>
            <p:nvSpPr>
              <p:cNvPr id="305" name="TextBox 304"/>
              <p:cNvSpPr txBox="1"/>
              <p:nvPr/>
            </p:nvSpPr>
            <p:spPr>
              <a:xfrm>
                <a:off x="5337040" y="729599"/>
                <a:ext cx="14742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/>
                    <a:cs typeface="Arial"/>
                  </a:rPr>
                  <a:t>Direct GO count (CC)</a:t>
                </a:r>
              </a:p>
            </p:txBody>
          </p:sp>
          <p:sp>
            <p:nvSpPr>
              <p:cNvPr id="307" name="TextBox 306"/>
              <p:cNvSpPr txBox="1"/>
              <p:nvPr/>
            </p:nvSpPr>
            <p:spPr>
              <a:xfrm>
                <a:off x="3506804" y="719941"/>
                <a:ext cx="1474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/>
                    <a:cs typeface="Arial"/>
                  </a:rPr>
                  <a:t>Direct GO count (MF)</a:t>
                </a:r>
              </a:p>
            </p:txBody>
          </p:sp>
          <p:sp>
            <p:nvSpPr>
              <p:cNvPr id="309" name="TextBox 308"/>
              <p:cNvSpPr txBox="1"/>
              <p:nvPr/>
            </p:nvSpPr>
            <p:spPr>
              <a:xfrm>
                <a:off x="555299" y="715486"/>
                <a:ext cx="14675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/>
                    <a:cs typeface="Arial"/>
                  </a:rPr>
                  <a:t>Biological processes</a:t>
                </a:r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>
              <a:off x="386442" y="6617197"/>
              <a:ext cx="2726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BP </a:t>
              </a:r>
              <a:r>
                <a:rPr lang="en-US" sz="1000" b="1" dirty="0" err="1" smtClean="0">
                  <a:latin typeface="Arial"/>
                  <a:cs typeface="Arial"/>
                </a:rPr>
                <a:t>upregulated</a:t>
              </a:r>
              <a:r>
                <a:rPr lang="en-US" sz="1000" b="1" dirty="0" smtClean="0">
                  <a:latin typeface="Arial"/>
                  <a:cs typeface="Arial"/>
                </a:rPr>
                <a:t> and </a:t>
              </a:r>
              <a:r>
                <a:rPr lang="en-US" sz="1000" b="1" dirty="0" err="1" smtClean="0">
                  <a:latin typeface="Arial"/>
                  <a:cs typeface="Arial"/>
                </a:rPr>
                <a:t>downregulated</a:t>
              </a:r>
              <a:r>
                <a:rPr lang="en-US" sz="1000" b="1" dirty="0" smtClean="0">
                  <a:latin typeface="Arial"/>
                  <a:cs typeface="Arial"/>
                </a:rPr>
                <a:t> DEGs</a:t>
              </a:r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2"/>
            <a:srcRect l="7699" t="2323" r="5777" b="8455"/>
            <a:stretch/>
          </p:blipFill>
          <p:spPr>
            <a:xfrm>
              <a:off x="-1408" y="1297490"/>
              <a:ext cx="2922860" cy="2279382"/>
            </a:xfrm>
            <a:prstGeom prst="rect">
              <a:avLst/>
            </a:prstGeom>
          </p:spPr>
        </p:pic>
        <p:graphicFrame>
          <p:nvGraphicFramePr>
            <p:cNvPr id="43" name="Chart 4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44184555"/>
                </p:ext>
              </p:extLst>
            </p:nvPr>
          </p:nvGraphicFramePr>
          <p:xfrm>
            <a:off x="169154" y="6799327"/>
            <a:ext cx="6642093" cy="25433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2" name="Chart 5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30939280"/>
                </p:ext>
              </p:extLst>
            </p:nvPr>
          </p:nvGraphicFramePr>
          <p:xfrm>
            <a:off x="45115" y="3873997"/>
            <a:ext cx="3585119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0" name="Chart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60384151"/>
                </p:ext>
              </p:extLst>
            </p:nvPr>
          </p:nvGraphicFramePr>
          <p:xfrm>
            <a:off x="2482698" y="986849"/>
            <a:ext cx="3238500" cy="46336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1" name="Rectangle 292"/>
            <p:cNvSpPr>
              <a:spLocks noChangeArrowheads="1"/>
            </p:cNvSpPr>
            <p:nvPr/>
          </p:nvSpPr>
          <p:spPr bwMode="auto">
            <a:xfrm>
              <a:off x="-85950" y="3501736"/>
              <a:ext cx="397164" cy="30777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/>
            <a:p>
              <a:pPr algn="ctr" fontAlgn="b">
                <a:defRPr/>
              </a:pPr>
              <a:r>
                <a:rPr lang="en-US" sz="1400" b="1" dirty="0" smtClean="0">
                  <a:latin typeface="+mj-lt"/>
                  <a:ea typeface="ＭＳ Ｐゴシック" charset="0"/>
                </a:rPr>
                <a:t>(B)</a:t>
              </a:r>
              <a:endParaRPr lang="en-US" sz="1400" b="1" dirty="0">
                <a:latin typeface="+mj-lt"/>
                <a:ea typeface="ＭＳ Ｐゴシック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74295" y="3564972"/>
              <a:ext cx="2735382" cy="1991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 smtClean="0">
                  <a:latin typeface="Arial"/>
                  <a:cs typeface="Arial"/>
                </a:rPr>
                <a:t>MF </a:t>
              </a:r>
              <a:r>
                <a:rPr lang="en-US" sz="1000" b="1" dirty="0" err="1" smtClean="0">
                  <a:latin typeface="Arial"/>
                  <a:cs typeface="Arial"/>
                </a:rPr>
                <a:t>upregulated</a:t>
              </a:r>
              <a:r>
                <a:rPr lang="en-US" sz="1000" b="1" dirty="0" smtClean="0">
                  <a:latin typeface="Arial"/>
                  <a:cs typeface="Arial"/>
                </a:rPr>
                <a:t> and </a:t>
              </a:r>
              <a:r>
                <a:rPr lang="en-US" sz="1000" b="1" dirty="0" err="1" smtClean="0">
                  <a:latin typeface="Arial"/>
                  <a:cs typeface="Arial"/>
                </a:rPr>
                <a:t>downregulated</a:t>
              </a:r>
              <a:r>
                <a:rPr lang="en-US" sz="1000" b="1" dirty="0" smtClean="0">
                  <a:latin typeface="Arial"/>
                  <a:cs typeface="Arial"/>
                </a:rPr>
                <a:t> DEGs</a:t>
              </a:r>
            </a:p>
          </p:txBody>
        </p:sp>
        <p:graphicFrame>
          <p:nvGraphicFramePr>
            <p:cNvPr id="23" name="Chart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19236476"/>
                </p:ext>
              </p:extLst>
            </p:nvPr>
          </p:nvGraphicFramePr>
          <p:xfrm>
            <a:off x="4729816" y="1070264"/>
            <a:ext cx="2436049" cy="40954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27671" y="5601722"/>
              <a:ext cx="1404137" cy="1004158"/>
            </a:xfrm>
            <a:prstGeom prst="rect">
              <a:avLst/>
            </a:prstGeom>
          </p:spPr>
        </p:pic>
        <p:grpSp>
          <p:nvGrpSpPr>
            <p:cNvPr id="26" name="Group 25"/>
            <p:cNvGrpSpPr/>
            <p:nvPr/>
          </p:nvGrpSpPr>
          <p:grpSpPr>
            <a:xfrm>
              <a:off x="5031808" y="5601722"/>
              <a:ext cx="1408019" cy="993743"/>
              <a:chOff x="0" y="0"/>
              <a:chExt cx="9118600" cy="6521098"/>
            </a:xfrm>
          </p:grpSpPr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0" y="0"/>
                <a:ext cx="9118600" cy="6521098"/>
              </a:xfrm>
              <a:prstGeom prst="rect">
                <a:avLst/>
              </a:prstGeom>
            </p:spPr>
          </p:pic>
          <p:sp>
            <p:nvSpPr>
              <p:cNvPr id="28" name="Rectangle 66"/>
              <p:cNvSpPr>
                <a:spLocks noChangeArrowheads="1"/>
              </p:cNvSpPr>
              <p:nvPr/>
            </p:nvSpPr>
            <p:spPr bwMode="auto">
              <a:xfrm>
                <a:off x="6359348" y="316525"/>
                <a:ext cx="2007943" cy="5216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1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24hr_PMS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" name="Rectangle 66"/>
              <p:cNvSpPr>
                <a:spLocks noChangeArrowheads="1"/>
              </p:cNvSpPr>
              <p:nvPr/>
            </p:nvSpPr>
            <p:spPr bwMode="auto">
              <a:xfrm>
                <a:off x="6495723" y="5633501"/>
                <a:ext cx="2007943" cy="3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500" b="1" dirty="0" smtClean="0">
                    <a:solidFill>
                      <a:srgbClr val="0000FF"/>
                    </a:solidFill>
                  </a:rPr>
                  <a:t>72</a:t>
                </a:r>
                <a:r>
                  <a:rPr kumimoji="0" lang="en-US" altLang="en-US" sz="5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</a:rPr>
                  <a:t>hr_PMS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</a:endParaRPr>
              </a:p>
            </p:txBody>
          </p:sp>
          <p:sp>
            <p:nvSpPr>
              <p:cNvPr id="30" name="Rectangle 66"/>
              <p:cNvSpPr>
                <a:spLocks noChangeArrowheads="1"/>
              </p:cNvSpPr>
              <p:nvPr/>
            </p:nvSpPr>
            <p:spPr bwMode="auto">
              <a:xfrm>
                <a:off x="1325903" y="2071253"/>
                <a:ext cx="2077284" cy="504919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500" b="1" dirty="0" smtClean="0">
                    <a:solidFill>
                      <a:srgbClr val="FF33CC"/>
                    </a:solidFill>
                  </a:rPr>
                  <a:t>8day</a:t>
                </a:r>
                <a:r>
                  <a:rPr kumimoji="0" lang="en-US" altLang="en-US" sz="500" b="1" i="0" u="none" strike="noStrike" cap="none" normalizeH="0" baseline="0" dirty="0" smtClean="0">
                    <a:ln>
                      <a:noFill/>
                    </a:ln>
                    <a:solidFill>
                      <a:srgbClr val="FF33CC"/>
                    </a:solidFill>
                    <a:effectLst/>
                  </a:rPr>
                  <a:t>_PMS</a:t>
                </a:r>
                <a:endParaRPr kumimoji="0" lang="en-US" altLang="en-US" sz="500" b="0" i="0" u="none" strike="noStrike" cap="none" normalizeH="0" baseline="0" dirty="0" smtClean="0">
                  <a:ln>
                    <a:noFill/>
                  </a:ln>
                  <a:solidFill>
                    <a:srgbClr val="FF33CC"/>
                  </a:solidFill>
                  <a:effectLst/>
                </a:endParaRPr>
              </a:p>
            </p:txBody>
          </p:sp>
        </p:grpSp>
        <p:sp>
          <p:nvSpPr>
            <p:cNvPr id="31" name="Rectangle 66"/>
            <p:cNvSpPr>
              <a:spLocks noChangeArrowheads="1"/>
            </p:cNvSpPr>
            <p:nvPr/>
          </p:nvSpPr>
          <p:spPr bwMode="auto">
            <a:xfrm>
              <a:off x="4585348" y="5655060"/>
              <a:ext cx="31005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24hr_PMS</a:t>
              </a:r>
              <a:endParaRPr kumimoji="0" lang="en-US" altLang="en-US" sz="5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66"/>
            <p:cNvSpPr>
              <a:spLocks noChangeArrowheads="1"/>
            </p:cNvSpPr>
            <p:nvPr/>
          </p:nvSpPr>
          <p:spPr bwMode="auto">
            <a:xfrm>
              <a:off x="4619654" y="6422075"/>
              <a:ext cx="310050" cy="1024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b="1" dirty="0" smtClean="0">
                  <a:solidFill>
                    <a:srgbClr val="0000FF"/>
                  </a:solidFill>
                </a:rPr>
                <a:t>72</a:t>
              </a:r>
              <a:r>
                <a:rPr kumimoji="0" lang="en-US" altLang="en-US" sz="500" b="1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</a:rPr>
                <a:t>hr_PMS</a:t>
              </a:r>
              <a:endParaRPr kumimoji="0" lang="en-US" altLang="en-US" sz="5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</a:endParaRPr>
            </a:p>
          </p:txBody>
        </p:sp>
        <p:sp>
          <p:nvSpPr>
            <p:cNvPr id="33" name="Rectangle 66"/>
            <p:cNvSpPr>
              <a:spLocks noChangeArrowheads="1"/>
            </p:cNvSpPr>
            <p:nvPr/>
          </p:nvSpPr>
          <p:spPr bwMode="auto">
            <a:xfrm>
              <a:off x="3824461" y="5902145"/>
              <a:ext cx="320757" cy="39485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b="1" dirty="0" smtClean="0">
                  <a:solidFill>
                    <a:srgbClr val="FF33CC"/>
                  </a:solidFill>
                </a:rPr>
                <a:t>8day</a:t>
              </a:r>
              <a:r>
                <a:rPr kumimoji="0" lang="en-US" altLang="en-US" sz="500" b="1" i="0" u="none" strike="noStrike" cap="none" normalizeH="0" baseline="0" dirty="0" smtClean="0">
                  <a:ln>
                    <a:noFill/>
                  </a:ln>
                  <a:solidFill>
                    <a:srgbClr val="FF33CC"/>
                  </a:solidFill>
                  <a:effectLst/>
                </a:rPr>
                <a:t>_PMS</a:t>
              </a:r>
              <a:endParaRPr kumimoji="0" lang="en-US" altLang="en-US" sz="500" b="0" i="0" u="none" strike="noStrike" cap="none" normalizeH="0" baseline="0" dirty="0" smtClean="0">
                <a:ln>
                  <a:noFill/>
                </a:ln>
                <a:solidFill>
                  <a:srgbClr val="FF33CC"/>
                </a:solidFill>
                <a:effectLst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801390" y="5465597"/>
              <a:ext cx="10567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err="1" smtClean="0">
                  <a:latin typeface="Arial"/>
                  <a:cs typeface="Arial"/>
                </a:rPr>
                <a:t>Upregulated</a:t>
              </a:r>
              <a:r>
                <a:rPr lang="en-US" sz="600" b="1" dirty="0" smtClean="0">
                  <a:latin typeface="Arial"/>
                  <a:cs typeface="Arial"/>
                </a:rPr>
                <a:t> DEGs PMS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363118" y="5453753"/>
              <a:ext cx="115942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err="1" smtClean="0">
                  <a:latin typeface="Arial"/>
                  <a:cs typeface="Arial"/>
                </a:rPr>
                <a:t>Downregulated</a:t>
              </a:r>
              <a:r>
                <a:rPr lang="en-US" sz="600" b="1" dirty="0" smtClean="0">
                  <a:latin typeface="Arial"/>
                  <a:cs typeface="Arial"/>
                </a:rPr>
                <a:t> DEGs PMS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862349" y="5965300"/>
              <a:ext cx="181646" cy="59330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832</a:t>
              </a:r>
              <a:endParaRPr lang="en-US" sz="5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869462" y="6147365"/>
              <a:ext cx="181646" cy="16927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24</a:t>
              </a:r>
              <a:endParaRPr lang="en-US" sz="5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904930" y="6369620"/>
              <a:ext cx="181646" cy="78968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57</a:t>
              </a:r>
              <a:endParaRPr lang="en-US" sz="5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548170" y="5929151"/>
              <a:ext cx="181646" cy="16927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65</a:t>
              </a:r>
              <a:endParaRPr lang="en-US" sz="5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566561" y="6126945"/>
              <a:ext cx="181646" cy="16927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18</a:t>
              </a:r>
              <a:endParaRPr lang="en-US" sz="5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432339" y="6348299"/>
              <a:ext cx="181646" cy="16927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24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237055" y="5993234"/>
              <a:ext cx="181646" cy="40523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752</a:t>
              </a:r>
              <a:endParaRPr lang="en-US" sz="5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260408" y="6117418"/>
              <a:ext cx="181646" cy="16927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15</a:t>
              </a:r>
              <a:endParaRPr lang="en-US" sz="5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282884" y="6352665"/>
              <a:ext cx="181646" cy="16927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22</a:t>
              </a:r>
              <a:endParaRPr lang="en-US" sz="5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958604" y="5905700"/>
              <a:ext cx="181646" cy="16927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40</a:t>
              </a:r>
              <a:endParaRPr lang="en-US" sz="5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941267" y="6119734"/>
              <a:ext cx="181646" cy="16927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16</a:t>
              </a:r>
              <a:endParaRPr lang="en-US" sz="5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988691" y="6345534"/>
              <a:ext cx="181646" cy="105107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15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020181" y="5732060"/>
              <a:ext cx="181646" cy="65263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44</a:t>
              </a:r>
              <a:endParaRPr lang="en-US" sz="5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566561" y="5748136"/>
              <a:ext cx="181646" cy="33490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500" dirty="0" smtClean="0"/>
                <a:t>113</a:t>
              </a:r>
              <a:endParaRPr lang="en-US" sz="500" dirty="0"/>
            </a:p>
          </p:txBody>
        </p:sp>
        <p:sp>
          <p:nvSpPr>
            <p:cNvPr id="60" name="Rectangle 292"/>
            <p:cNvSpPr>
              <a:spLocks noChangeArrowheads="1"/>
            </p:cNvSpPr>
            <p:nvPr/>
          </p:nvSpPr>
          <p:spPr bwMode="auto">
            <a:xfrm>
              <a:off x="3422821" y="5182684"/>
              <a:ext cx="409700" cy="30777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>
              <a:spAutoFit/>
            </a:bodyPr>
            <a:lstStyle/>
            <a:p>
              <a:pPr algn="ctr" fontAlgn="b">
                <a:defRPr/>
              </a:pPr>
              <a:r>
                <a:rPr lang="en-US" sz="1400" b="1" dirty="0" smtClean="0">
                  <a:latin typeface="+mj-lt"/>
                  <a:ea typeface="ＭＳ Ｐゴシック" charset="0"/>
                </a:rPr>
                <a:t>(D)</a:t>
              </a:r>
              <a:endParaRPr lang="en-US" sz="1400" b="1" dirty="0">
                <a:latin typeface="+mj-lt"/>
                <a:ea typeface="ＭＳ Ｐゴシック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14934" y="-10168"/>
            <a:ext cx="684306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Elucidation of Resistance Signaling and Identification of Powdery Mildew Resistant Mapping Loci (ClaPMR2) during Watermelon-</a:t>
            </a:r>
            <a:r>
              <a:rPr lang="en-US" sz="800" i="1" dirty="0" err="1">
                <a:latin typeface="Arial"/>
                <a:cs typeface="Arial"/>
              </a:rPr>
              <a:t>Podosphaera</a:t>
            </a:r>
            <a:r>
              <a:rPr lang="en-US" sz="800" i="1" dirty="0">
                <a:latin typeface="Arial"/>
                <a:cs typeface="Arial"/>
              </a:rPr>
              <a:t> </a:t>
            </a:r>
            <a:r>
              <a:rPr lang="en-US" sz="800" i="1" dirty="0" err="1">
                <a:latin typeface="Arial"/>
                <a:cs typeface="Arial"/>
              </a:rPr>
              <a:t>xanthii</a:t>
            </a:r>
            <a:r>
              <a:rPr lang="en-US" sz="800" i="1" dirty="0">
                <a:latin typeface="Arial"/>
                <a:cs typeface="Arial"/>
              </a:rPr>
              <a:t> </a:t>
            </a:r>
            <a:r>
              <a:rPr lang="en-US" sz="800" dirty="0">
                <a:latin typeface="Arial"/>
                <a:cs typeface="Arial"/>
              </a:rPr>
              <a:t>interaction using RNA-</a:t>
            </a:r>
            <a:r>
              <a:rPr lang="en-US" sz="800" dirty="0" err="1">
                <a:latin typeface="Arial"/>
                <a:cs typeface="Arial"/>
              </a:rPr>
              <a:t>Seq</a:t>
            </a:r>
            <a:r>
              <a:rPr lang="en-US" sz="800" dirty="0">
                <a:latin typeface="Arial"/>
                <a:cs typeface="Arial"/>
              </a:rPr>
              <a:t> and Whole-Genome </a:t>
            </a:r>
            <a:r>
              <a:rPr lang="en-US" sz="800" dirty="0" err="1">
                <a:latin typeface="Arial"/>
                <a:cs typeface="Arial"/>
              </a:rPr>
              <a:t>Resequencing</a:t>
            </a:r>
            <a:r>
              <a:rPr lang="en-US" sz="800" dirty="0">
                <a:latin typeface="Arial"/>
                <a:cs typeface="Arial"/>
              </a:rPr>
              <a:t> </a:t>
            </a:r>
            <a:r>
              <a:rPr lang="en-US" sz="800" dirty="0" smtClean="0">
                <a:latin typeface="Arial"/>
                <a:cs typeface="Arial"/>
              </a:rPr>
              <a:t>Approach. </a:t>
            </a:r>
          </a:p>
          <a:p>
            <a:pPr algn="ctr"/>
            <a:r>
              <a:rPr lang="en-US" sz="800" dirty="0" smtClean="0">
                <a:latin typeface="Arial"/>
                <a:cs typeface="Arial"/>
              </a:rPr>
              <a:t>Mihir </a:t>
            </a:r>
            <a:r>
              <a:rPr lang="en-US" sz="800" dirty="0">
                <a:latin typeface="Arial"/>
                <a:cs typeface="Arial"/>
              </a:rPr>
              <a:t>Kumar </a:t>
            </a:r>
            <a:r>
              <a:rPr lang="en-US" sz="800" dirty="0" smtClean="0">
                <a:latin typeface="Arial"/>
                <a:cs typeface="Arial"/>
              </a:rPr>
              <a:t>Mandal, </a:t>
            </a:r>
            <a:r>
              <a:rPr lang="en-US" sz="800" dirty="0" err="1">
                <a:latin typeface="Arial"/>
                <a:cs typeface="Arial"/>
              </a:rPr>
              <a:t>Haktan</a:t>
            </a:r>
            <a:r>
              <a:rPr lang="en-US" sz="800" dirty="0">
                <a:latin typeface="Arial"/>
                <a:cs typeface="Arial"/>
              </a:rPr>
              <a:t> </a:t>
            </a:r>
            <a:r>
              <a:rPr lang="en-US" sz="800" dirty="0" err="1" smtClean="0">
                <a:latin typeface="Arial"/>
                <a:cs typeface="Arial"/>
              </a:rPr>
              <a:t>Suren</a:t>
            </a:r>
            <a:r>
              <a:rPr lang="en-US" sz="800" dirty="0" smtClean="0">
                <a:latin typeface="Arial"/>
                <a:cs typeface="Arial"/>
              </a:rPr>
              <a:t>, </a:t>
            </a:r>
            <a:r>
              <a:rPr lang="en-US" sz="800" dirty="0" err="1">
                <a:latin typeface="Arial"/>
                <a:cs typeface="Arial"/>
              </a:rPr>
              <a:t>Chandrasekar</a:t>
            </a:r>
            <a:r>
              <a:rPr lang="en-US" sz="800" dirty="0">
                <a:latin typeface="Arial"/>
                <a:cs typeface="Arial"/>
              </a:rPr>
              <a:t> </a:t>
            </a:r>
            <a:r>
              <a:rPr lang="en-US" sz="800" dirty="0" err="1" smtClean="0">
                <a:latin typeface="Arial"/>
                <a:cs typeface="Arial"/>
              </a:rPr>
              <a:t>Kousik</a:t>
            </a:r>
            <a:endParaRPr lang="en-US" sz="8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571818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674</TotalTime>
  <Words>146</Words>
  <Application>Microsoft Macintosh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Kentuck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isha Chanda</dc:creator>
  <cp:lastModifiedBy>Mihir Mandal</cp:lastModifiedBy>
  <cp:revision>250</cp:revision>
  <dcterms:created xsi:type="dcterms:W3CDTF">2017-10-14T20:57:04Z</dcterms:created>
  <dcterms:modified xsi:type="dcterms:W3CDTF">2020-06-15T15:47:43Z</dcterms:modified>
</cp:coreProperties>
</file>